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158" autoAdjust="0"/>
    <p:restoredTop sz="94660"/>
  </p:normalViewPr>
  <p:slideViewPr>
    <p:cSldViewPr snapToGrid="0">
      <p:cViewPr>
        <p:scale>
          <a:sx n="100" d="100"/>
          <a:sy n="100" d="100"/>
        </p:scale>
        <p:origin x="1440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736A5B6-8878-4A71-B108-355BF3253F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69A40FD7-40A3-4A4F-BD6B-426FF38FBC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F1488AF-80D4-4692-97DB-1A213C9179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4268E9E-61B2-42B8-BD66-4E9EC0C75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E5E2B56-2340-4110-8677-405DFAB0A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9514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56E9B61-161A-426E-B9BB-D0629BCA49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9488BC9B-CEB2-46CD-9F88-B1867EC308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F3F5FCD-48E1-42D0-84E9-4C7AA6F548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AC9FBAF-9168-4DA2-9F3A-22B157E47C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A893323-50F2-4F5E-99B2-95D17C6CC4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5662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656AA4CF-FAC7-4437-9ECD-10CA39EB90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8D7B83E-ABAC-428D-B164-40EEE343AE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4DDC85A-530E-4174-96E3-06E9E73D47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F0A18B2-C999-4B18-B812-58D1FDBFE4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0A88BDB-DF80-44FB-BE82-03697D596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2681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865403F-321C-4662-8D43-75F970EC0D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3F21FD2-3EC1-4F06-9C64-8B56BBA0EA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3D3D689-0C8D-408E-9A5F-FB6EAA66C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1E60C5B-A6D3-401C-BB63-8F21EE9230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6EA12A1-D4EA-4BCF-8910-65FF994B1A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682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CF296A7-49D5-42E1-ADF1-39F50AD87E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B4A7589-DBD1-414F-92AB-573121D03A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8B2E2D6-50D5-48D8-9D80-10941F9D80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8A231EE-DA4A-459A-A0B7-31AA78D77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1A61B1D-6203-4369-8C84-4479934931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586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C255C8F-5C30-4355-9102-8909005A52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0E8F41D-2077-47B2-9B60-EFB95B96E8E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943070C-84D3-47D3-B969-49D8BD09C2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7709057-A18F-441E-B6E4-BFF9F85DC2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B5CFEA4-F927-464C-9075-FAF2FBA896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8C7F3D1-2A46-4775-93F4-CF694E8195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973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AE4E18F-D55F-46FB-99EE-DD3225062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E7AC9F3-C1BF-46FA-B6A5-D567B75930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93510365-93D3-4AD9-88A7-3A109AE52E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68EA7854-7A7B-4EFA-8E8B-CFC0B21C42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5107A9F6-163A-4323-99B4-1A96D13F5CD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C494632E-FB8E-498B-9A01-2F6B1F1D1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B77013E3-02EC-4137-B367-FA2CD69C35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1A920C32-2B12-4F36-BF66-470A9BA4A0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522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7B69866-571E-4CD1-AEB3-7336BED570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8A1574BA-0B98-4461-8FFB-E194FBDD41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DC54160B-4074-4924-AAE3-F9C3228872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B13AB193-6C6D-4C8E-99D6-6F07D0ADD9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249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3D14CDCB-FCFD-4A81-9647-BC645301D7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3C5869F9-4A06-4A38-8F40-03DF11EC1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B7855DA2-6C9B-4EEA-9413-C32C12223D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95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44EAD25-741D-422E-9FEF-DC10CCBAD0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377D144-CAAD-44F7-A7F6-76E00EB882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456E78FD-406D-4C74-B37E-6D4F0EB278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9222253-9146-4562-8800-171EBDE46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46D9D77-744B-4D40-8D01-CD26C0B1A5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465ACE0-FCF5-4D64-BD04-FB36C9BF9D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973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2BA466F-E10F-435F-90BB-DE6DBBE5D4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B22FB51A-43E2-43CE-84D0-13865DAFCF8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10C4DDF3-A063-4872-9762-DC98DB5BE5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A1E36B9-EB31-4608-AB09-008AF580AA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37999-96FD-4CB1-B0A2-B5A92935E967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E9A8883-CBAF-4348-A55E-D93866407A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60C9D99-1959-4B5C-85D5-359AEB523D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1775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EAD94524-8AC3-4A6C-8E7E-F64A4C7C52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3287015-3633-456C-A198-B300AE2AA9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3D7673D-31FD-4822-8775-2E4A40EDB6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A37999-96FD-4CB1-B0A2-B5A92935E967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86D2390-DC34-45C2-A126-624B50E89E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609B900-BE89-4E0A-B572-8968892B44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021A43-78E5-45F5-9161-3D86CAA501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6136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>
            <a:extLst>
              <a:ext uri="{FF2B5EF4-FFF2-40B4-BE49-F238E27FC236}">
                <a16:creationId xmlns:a16="http://schemas.microsoft.com/office/drawing/2014/main" id="{CEEDD393-E7CA-4167-A408-B1B9163869B4}"/>
              </a:ext>
            </a:extLst>
          </p:cNvPr>
          <p:cNvSpPr/>
          <p:nvPr/>
        </p:nvSpPr>
        <p:spPr>
          <a:xfrm>
            <a:off x="0" y="1"/>
            <a:ext cx="11268075" cy="68326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5967" name="Gruppieren 5966">
            <a:extLst>
              <a:ext uri="{FF2B5EF4-FFF2-40B4-BE49-F238E27FC236}">
                <a16:creationId xmlns:a16="http://schemas.microsoft.com/office/drawing/2014/main" id="{98A31364-892D-474C-A454-5FC05B7A4C53}"/>
              </a:ext>
            </a:extLst>
          </p:cNvPr>
          <p:cNvGrpSpPr/>
          <p:nvPr/>
        </p:nvGrpSpPr>
        <p:grpSpPr>
          <a:xfrm>
            <a:off x="59461" y="304897"/>
            <a:ext cx="10875240" cy="6248206"/>
            <a:chOff x="59461" y="304897"/>
            <a:chExt cx="10875240" cy="6248206"/>
          </a:xfrm>
        </p:grpSpPr>
        <p:sp>
          <p:nvSpPr>
            <p:cNvPr id="5" name="Freihandform: Form 4">
              <a:extLst>
                <a:ext uri="{FF2B5EF4-FFF2-40B4-BE49-F238E27FC236}">
                  <a16:creationId xmlns:a16="http://schemas.microsoft.com/office/drawing/2014/main" id="{B1FC8DDC-E89A-473B-A425-2BF69F4E4452}"/>
                </a:ext>
              </a:extLst>
            </p:cNvPr>
            <p:cNvSpPr/>
            <p:nvPr/>
          </p:nvSpPr>
          <p:spPr>
            <a:xfrm>
              <a:off x="59461" y="304897"/>
              <a:ext cx="10875240" cy="6248206"/>
            </a:xfrm>
            <a:custGeom>
              <a:avLst/>
              <a:gdLst>
                <a:gd name="connsiteX0" fmla="*/ 0 w 9601200"/>
                <a:gd name="connsiteY0" fmla="*/ 0 h 6858000"/>
                <a:gd name="connsiteX1" fmla="*/ 9601200 w 9601200"/>
                <a:gd name="connsiteY1" fmla="*/ 0 h 6858000"/>
                <a:gd name="connsiteX2" fmla="*/ 9601200 w 9601200"/>
                <a:gd name="connsiteY2" fmla="*/ 6858000 h 6858000"/>
                <a:gd name="connsiteX3" fmla="*/ 0 w 9601200"/>
                <a:gd name="connsiteY3" fmla="*/ 6858000 h 6858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9601200" h="6858000">
                  <a:moveTo>
                    <a:pt x="0" y="0"/>
                  </a:moveTo>
                  <a:lnTo>
                    <a:pt x="9601200" y="0"/>
                  </a:lnTo>
                  <a:lnTo>
                    <a:pt x="9601200" y="6858000"/>
                  </a:lnTo>
                  <a:lnTo>
                    <a:pt x="0" y="6858000"/>
                  </a:lnTo>
                  <a:close/>
                </a:path>
              </a:pathLst>
            </a:custGeom>
            <a:solidFill>
              <a:srgbClr val="FFFFFF"/>
            </a:solidFill>
            <a:ln w="9525" cap="flat">
              <a:noFill/>
              <a:prstDash val="solid"/>
              <a:miter/>
            </a:ln>
          </p:spPr>
          <p:txBody>
            <a:bodyPr rtlCol="0" anchor="ctr"/>
            <a:lstStyle/>
            <a:p>
              <a:pPr algn="ctr"/>
              <a:endParaRPr lang="en-US" sz="1100" b="1" dirty="0"/>
            </a:p>
          </p:txBody>
        </p:sp>
        <p:sp>
          <p:nvSpPr>
            <p:cNvPr id="5861" name="Textfeld 5860">
              <a:extLst>
                <a:ext uri="{FF2B5EF4-FFF2-40B4-BE49-F238E27FC236}">
                  <a16:creationId xmlns:a16="http://schemas.microsoft.com/office/drawing/2014/main" id="{23F13CB3-69CC-4F9D-9109-B6A1C71706F7}"/>
                </a:ext>
              </a:extLst>
            </p:cNvPr>
            <p:cNvSpPr txBox="1"/>
            <p:nvPr/>
          </p:nvSpPr>
          <p:spPr>
            <a:xfrm>
              <a:off x="64655" y="304897"/>
              <a:ext cx="25861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/>
                <a:t>A</a:t>
              </a:r>
            </a:p>
          </p:txBody>
        </p:sp>
        <p:sp>
          <p:nvSpPr>
            <p:cNvPr id="5862" name="Textfeld 5861">
              <a:extLst>
                <a:ext uri="{FF2B5EF4-FFF2-40B4-BE49-F238E27FC236}">
                  <a16:creationId xmlns:a16="http://schemas.microsoft.com/office/drawing/2014/main" id="{961E72E3-856B-4506-BDD6-4CA3912489FB}"/>
                </a:ext>
              </a:extLst>
            </p:cNvPr>
            <p:cNvSpPr txBox="1"/>
            <p:nvPr/>
          </p:nvSpPr>
          <p:spPr>
            <a:xfrm>
              <a:off x="5299710" y="304897"/>
              <a:ext cx="25861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/>
                <a:t>B</a:t>
              </a:r>
            </a:p>
          </p:txBody>
        </p:sp>
        <p:grpSp>
          <p:nvGrpSpPr>
            <p:cNvPr id="5966" name="Gruppieren 5965">
              <a:extLst>
                <a:ext uri="{FF2B5EF4-FFF2-40B4-BE49-F238E27FC236}">
                  <a16:creationId xmlns:a16="http://schemas.microsoft.com/office/drawing/2014/main" id="{C7E552F1-A89D-4C42-ABD3-81E21EC4E625}"/>
                </a:ext>
              </a:extLst>
            </p:cNvPr>
            <p:cNvGrpSpPr/>
            <p:nvPr/>
          </p:nvGrpSpPr>
          <p:grpSpPr>
            <a:xfrm>
              <a:off x="5155712" y="517411"/>
              <a:ext cx="5633802" cy="5968636"/>
              <a:chOff x="5374787" y="536461"/>
              <a:chExt cx="5633802" cy="5968636"/>
            </a:xfrm>
          </p:grpSpPr>
          <p:sp>
            <p:nvSpPr>
              <p:cNvPr id="7" name="Textfeld 6">
                <a:extLst>
                  <a:ext uri="{FF2B5EF4-FFF2-40B4-BE49-F238E27FC236}">
                    <a16:creationId xmlns:a16="http://schemas.microsoft.com/office/drawing/2014/main" id="{2F0DF226-9D1F-4EE0-BB6C-67C8A8830ED9}"/>
                  </a:ext>
                </a:extLst>
              </p:cNvPr>
              <p:cNvSpPr txBox="1"/>
              <p:nvPr/>
            </p:nvSpPr>
            <p:spPr>
              <a:xfrm>
                <a:off x="5691273" y="536461"/>
                <a:ext cx="531731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 err="1"/>
                  <a:t>Reactome</a:t>
                </a:r>
                <a:r>
                  <a:rPr lang="en-US" sz="1600" b="1" dirty="0"/>
                  <a:t> analysis non-dissected proteome data</a:t>
                </a:r>
              </a:p>
            </p:txBody>
          </p:sp>
          <p:grpSp>
            <p:nvGrpSpPr>
              <p:cNvPr id="5964" name="Gruppieren 5963">
                <a:extLst>
                  <a:ext uri="{FF2B5EF4-FFF2-40B4-BE49-F238E27FC236}">
                    <a16:creationId xmlns:a16="http://schemas.microsoft.com/office/drawing/2014/main" id="{A5F971B1-A42C-4725-BE2E-8FE1B8C8D7C0}"/>
                  </a:ext>
                </a:extLst>
              </p:cNvPr>
              <p:cNvGrpSpPr/>
              <p:nvPr/>
            </p:nvGrpSpPr>
            <p:grpSpPr>
              <a:xfrm>
                <a:off x="5374787" y="906134"/>
                <a:ext cx="5633802" cy="5598963"/>
                <a:chOff x="5374787" y="906134"/>
                <a:chExt cx="5633802" cy="5598963"/>
              </a:xfrm>
            </p:grpSpPr>
            <p:grpSp>
              <p:nvGrpSpPr>
                <p:cNvPr id="5963" name="Gruppieren 5962">
                  <a:extLst>
                    <a:ext uri="{FF2B5EF4-FFF2-40B4-BE49-F238E27FC236}">
                      <a16:creationId xmlns:a16="http://schemas.microsoft.com/office/drawing/2014/main" id="{593FE803-4D33-451E-8C50-507D11F8E295}"/>
                    </a:ext>
                  </a:extLst>
                </p:cNvPr>
                <p:cNvGrpSpPr/>
                <p:nvPr/>
              </p:nvGrpSpPr>
              <p:grpSpPr>
                <a:xfrm>
                  <a:off x="5374787" y="906134"/>
                  <a:ext cx="5519989" cy="3252613"/>
                  <a:chOff x="5374787" y="906134"/>
                  <a:chExt cx="5519989" cy="3252613"/>
                </a:xfrm>
              </p:grpSpPr>
              <p:grpSp>
                <p:nvGrpSpPr>
                  <p:cNvPr id="5957" name="Gruppieren 5956">
                    <a:extLst>
                      <a:ext uri="{FF2B5EF4-FFF2-40B4-BE49-F238E27FC236}">
                        <a16:creationId xmlns:a16="http://schemas.microsoft.com/office/drawing/2014/main" id="{61BF3FC6-808F-4413-993A-EB00EB79E9C3}"/>
                      </a:ext>
                    </a:extLst>
                  </p:cNvPr>
                  <p:cNvGrpSpPr/>
                  <p:nvPr/>
                </p:nvGrpSpPr>
                <p:grpSpPr>
                  <a:xfrm>
                    <a:off x="5374787" y="906134"/>
                    <a:ext cx="5318330" cy="3252613"/>
                    <a:chOff x="5374787" y="610859"/>
                    <a:chExt cx="5318330" cy="3252613"/>
                  </a:xfrm>
                </p:grpSpPr>
                <p:sp>
                  <p:nvSpPr>
                    <p:cNvPr id="3018" name="Textfeld 3017">
                      <a:extLst>
                        <a:ext uri="{FF2B5EF4-FFF2-40B4-BE49-F238E27FC236}">
                          <a16:creationId xmlns:a16="http://schemas.microsoft.com/office/drawing/2014/main" id="{F26054DA-6126-4BE2-BFB4-EC807FB147D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180967" y="610859"/>
                      <a:ext cx="2399201" cy="261610"/>
                    </a:xfrm>
                    <a:prstGeom prst="rect">
                      <a:avLst/>
                    </a:prstGeom>
                    <a:noFill/>
                    <a:ln w="19050">
                      <a:solidFill>
                        <a:schemeClr val="accent4">
                          <a:lumMod val="60000"/>
                          <a:lumOff val="40000"/>
                        </a:schemeClr>
                      </a:solidFill>
                    </a:ln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100" b="1" dirty="0"/>
                        <a:t>Upregulated in liver metastasis</a:t>
                      </a:r>
                    </a:p>
                  </p:txBody>
                </p:sp>
                <p:grpSp>
                  <p:nvGrpSpPr>
                    <p:cNvPr id="5889" name="Gruppieren 5888">
                      <a:extLst>
                        <a:ext uri="{FF2B5EF4-FFF2-40B4-BE49-F238E27FC236}">
                          <a16:creationId xmlns:a16="http://schemas.microsoft.com/office/drawing/2014/main" id="{9180EDB2-747E-4080-B5E1-B0D60C7C102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374787" y="883800"/>
                      <a:ext cx="5318330" cy="2979672"/>
                      <a:chOff x="118194" y="1223963"/>
                      <a:chExt cx="5984902" cy="3353128"/>
                    </a:xfrm>
                  </p:grpSpPr>
                  <p:pic>
                    <p:nvPicPr>
                      <p:cNvPr id="5873" name="Grafik 5872">
                        <a:extLst>
                          <a:ext uri="{FF2B5EF4-FFF2-40B4-BE49-F238E27FC236}">
                            <a16:creationId xmlns:a16="http://schemas.microsoft.com/office/drawing/2014/main" id="{ECE1656E-9D9D-4717-A25A-D51F5A820253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20576" t="3500" r="5569" b="5682"/>
                      <a:stretch/>
                    </p:blipFill>
                    <p:spPr>
                      <a:xfrm>
                        <a:off x="1728789" y="1223963"/>
                        <a:ext cx="4001197" cy="2993747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5874" name="Textfeld 5873">
                        <a:extLst>
                          <a:ext uri="{FF2B5EF4-FFF2-40B4-BE49-F238E27FC236}">
                            <a16:creationId xmlns:a16="http://schemas.microsoft.com/office/drawing/2014/main" id="{B8B62B5A-7A21-4EDA-A4B1-EF23A93A69C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65485" y="1295618"/>
                        <a:ext cx="1541546" cy="22512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700" b="1" dirty="0"/>
                          <a:t>Metabolism</a:t>
                        </a:r>
                      </a:p>
                    </p:txBody>
                  </p:sp>
                  <p:sp>
                    <p:nvSpPr>
                      <p:cNvPr id="5875" name="Textfeld 5874">
                        <a:extLst>
                          <a:ext uri="{FF2B5EF4-FFF2-40B4-BE49-F238E27FC236}">
                            <a16:creationId xmlns:a16="http://schemas.microsoft.com/office/drawing/2014/main" id="{E5181F1F-26D2-4EEA-86A6-6867135305A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65485" y="1590014"/>
                        <a:ext cx="1541546" cy="22512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700" b="1" dirty="0"/>
                          <a:t>Biological oxidations</a:t>
                        </a:r>
                      </a:p>
                    </p:txBody>
                  </p:sp>
                  <p:sp>
                    <p:nvSpPr>
                      <p:cNvPr id="5876" name="Textfeld 5875">
                        <a:extLst>
                          <a:ext uri="{FF2B5EF4-FFF2-40B4-BE49-F238E27FC236}">
                            <a16:creationId xmlns:a16="http://schemas.microsoft.com/office/drawing/2014/main" id="{721A9B8C-51AE-4221-B2E2-73213DC7AFD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65485" y="1876686"/>
                        <a:ext cx="1541546" cy="34635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700" b="1" dirty="0"/>
                          <a:t>Metabolism of carbohydrates</a:t>
                        </a:r>
                      </a:p>
                    </p:txBody>
                  </p:sp>
                  <p:sp>
                    <p:nvSpPr>
                      <p:cNvPr id="5877" name="Textfeld 5876">
                        <a:extLst>
                          <a:ext uri="{FF2B5EF4-FFF2-40B4-BE49-F238E27FC236}">
                            <a16:creationId xmlns:a16="http://schemas.microsoft.com/office/drawing/2014/main" id="{C0E7AEC4-4301-4F73-8CDB-B291784BF25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65485" y="2104186"/>
                        <a:ext cx="1541546" cy="34635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700" b="1" dirty="0"/>
                          <a:t>Metabolism of vitamins and cofactors</a:t>
                        </a:r>
                      </a:p>
                    </p:txBody>
                  </p:sp>
                  <p:sp>
                    <p:nvSpPr>
                      <p:cNvPr id="5878" name="Textfeld 5877">
                        <a:extLst>
                          <a:ext uri="{FF2B5EF4-FFF2-40B4-BE49-F238E27FC236}">
                            <a16:creationId xmlns:a16="http://schemas.microsoft.com/office/drawing/2014/main" id="{679B60C0-84DA-4E34-8332-5C14DF103AC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65485" y="2453425"/>
                        <a:ext cx="1541546" cy="22512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700" b="1" dirty="0"/>
                          <a:t>Disease of metabolism</a:t>
                        </a:r>
                      </a:p>
                    </p:txBody>
                  </p:sp>
                  <p:sp>
                    <p:nvSpPr>
                      <p:cNvPr id="5879" name="Textfeld 5878">
                        <a:extLst>
                          <a:ext uri="{FF2B5EF4-FFF2-40B4-BE49-F238E27FC236}">
                            <a16:creationId xmlns:a16="http://schemas.microsoft.com/office/drawing/2014/main" id="{E06966AE-99CC-49E7-8A84-C42E8C7BC9C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65485" y="2684709"/>
                        <a:ext cx="1541546" cy="46757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700" b="1" dirty="0"/>
                          <a:t>Phase I – Functionalization of compounds</a:t>
                        </a:r>
                      </a:p>
                    </p:txBody>
                  </p:sp>
                  <p:sp>
                    <p:nvSpPr>
                      <p:cNvPr id="5880" name="Textfeld 5879">
                        <a:extLst>
                          <a:ext uri="{FF2B5EF4-FFF2-40B4-BE49-F238E27FC236}">
                            <a16:creationId xmlns:a16="http://schemas.microsoft.com/office/drawing/2014/main" id="{640B71EC-59A5-409C-B4C8-8D0ED627FA1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18194" y="2973616"/>
                        <a:ext cx="1688835" cy="34635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700" b="1" dirty="0"/>
                          <a:t>Metabolism of water-soluble vitamins and cofactors</a:t>
                        </a:r>
                      </a:p>
                    </p:txBody>
                  </p:sp>
                  <p:sp>
                    <p:nvSpPr>
                      <p:cNvPr id="5881" name="Textfeld 5880">
                        <a:extLst>
                          <a:ext uri="{FF2B5EF4-FFF2-40B4-BE49-F238E27FC236}">
                            <a16:creationId xmlns:a16="http://schemas.microsoft.com/office/drawing/2014/main" id="{C7C79A95-B33F-4E70-8861-D71DECAB855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65481" y="3325639"/>
                        <a:ext cx="1541546" cy="22512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700" b="1" dirty="0"/>
                          <a:t>Glucose metabolism</a:t>
                        </a:r>
                      </a:p>
                    </p:txBody>
                  </p:sp>
                  <p:sp>
                    <p:nvSpPr>
                      <p:cNvPr id="5882" name="Textfeld 5881">
                        <a:extLst>
                          <a:ext uri="{FF2B5EF4-FFF2-40B4-BE49-F238E27FC236}">
                            <a16:creationId xmlns:a16="http://schemas.microsoft.com/office/drawing/2014/main" id="{6DDF483D-6760-4E16-B75C-024E053C444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65481" y="3620034"/>
                        <a:ext cx="1541546" cy="22512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700" b="1" dirty="0"/>
                          <a:t>Fructose metabolism</a:t>
                        </a:r>
                      </a:p>
                    </p:txBody>
                  </p:sp>
                  <p:sp>
                    <p:nvSpPr>
                      <p:cNvPr id="5883" name="Textfeld 5882">
                        <a:extLst>
                          <a:ext uri="{FF2B5EF4-FFF2-40B4-BE49-F238E27FC236}">
                            <a16:creationId xmlns:a16="http://schemas.microsoft.com/office/drawing/2014/main" id="{B55029C4-C6FA-47E2-832D-27055D66F25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65481" y="3904903"/>
                        <a:ext cx="1541546" cy="22512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700" b="1" dirty="0"/>
                          <a:t>Fructose catabolism</a:t>
                        </a:r>
                      </a:p>
                    </p:txBody>
                  </p:sp>
                  <p:sp>
                    <p:nvSpPr>
                      <p:cNvPr id="5884" name="Textfeld 5883">
                        <a:extLst>
                          <a:ext uri="{FF2B5EF4-FFF2-40B4-BE49-F238E27FC236}">
                            <a16:creationId xmlns:a16="http://schemas.microsoft.com/office/drawing/2014/main" id="{67A2A003-B9E0-4284-87DA-9CCC95EB544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305853" y="4156753"/>
                        <a:ext cx="704850" cy="24244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b="1" dirty="0"/>
                          <a:t>0,2</a:t>
                        </a:r>
                      </a:p>
                    </p:txBody>
                  </p:sp>
                  <p:sp>
                    <p:nvSpPr>
                      <p:cNvPr id="5885" name="Textfeld 5884">
                        <a:extLst>
                          <a:ext uri="{FF2B5EF4-FFF2-40B4-BE49-F238E27FC236}">
                            <a16:creationId xmlns:a16="http://schemas.microsoft.com/office/drawing/2014/main" id="{CC826AB5-E003-4051-87F4-0D45D5501CD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222315" y="4156753"/>
                        <a:ext cx="704850" cy="24244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b="1" dirty="0"/>
                          <a:t>0,4</a:t>
                        </a:r>
                      </a:p>
                    </p:txBody>
                  </p:sp>
                  <p:sp>
                    <p:nvSpPr>
                      <p:cNvPr id="5886" name="Textfeld 5885">
                        <a:extLst>
                          <a:ext uri="{FF2B5EF4-FFF2-40B4-BE49-F238E27FC236}">
                            <a16:creationId xmlns:a16="http://schemas.microsoft.com/office/drawing/2014/main" id="{76EFE386-FE24-4942-9FD8-DB69BF020DB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138778" y="4156753"/>
                        <a:ext cx="704850" cy="24244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b="1" dirty="0"/>
                          <a:t>0,6</a:t>
                        </a:r>
                      </a:p>
                    </p:txBody>
                  </p:sp>
                  <p:sp>
                    <p:nvSpPr>
                      <p:cNvPr id="5887" name="Textfeld 5886">
                        <a:extLst>
                          <a:ext uri="{FF2B5EF4-FFF2-40B4-BE49-F238E27FC236}">
                            <a16:creationId xmlns:a16="http://schemas.microsoft.com/office/drawing/2014/main" id="{9E69E6B6-8EE8-4603-B490-D34F94E32CE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055240" y="4156753"/>
                        <a:ext cx="704850" cy="24244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b="1" dirty="0"/>
                          <a:t>0,8</a:t>
                        </a:r>
                      </a:p>
                    </p:txBody>
                  </p:sp>
                  <p:sp>
                    <p:nvSpPr>
                      <p:cNvPr id="5888" name="Textfeld 5887">
                        <a:extLst>
                          <a:ext uri="{FF2B5EF4-FFF2-40B4-BE49-F238E27FC236}">
                            <a16:creationId xmlns:a16="http://schemas.microsoft.com/office/drawing/2014/main" id="{F976F9EB-0659-4E66-8228-805EFE002C4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747941" y="4317328"/>
                        <a:ext cx="4355155" cy="25976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900" dirty="0"/>
                          <a:t>Gene ratio</a:t>
                        </a:r>
                      </a:p>
                    </p:txBody>
                  </p:sp>
                </p:grpSp>
              </p:grpSp>
              <p:pic>
                <p:nvPicPr>
                  <p:cNvPr id="5891" name="Grafik 5890">
                    <a:extLst>
                      <a:ext uri="{FF2B5EF4-FFF2-40B4-BE49-F238E27FC236}">
                        <a16:creationId xmlns:a16="http://schemas.microsoft.com/office/drawing/2014/main" id="{FD192BB5-89BF-414A-90AB-08F86B73D34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95208" t="29980" r="645" b="31988"/>
                  <a:stretch/>
                </p:blipFill>
                <p:spPr>
                  <a:xfrm>
                    <a:off x="10399175" y="1499232"/>
                    <a:ext cx="495601" cy="2020003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5959" name="Gruppieren 5958">
                  <a:extLst>
                    <a:ext uri="{FF2B5EF4-FFF2-40B4-BE49-F238E27FC236}">
                      <a16:creationId xmlns:a16="http://schemas.microsoft.com/office/drawing/2014/main" id="{6EDF767F-BF6B-4775-BBC8-CC3DE24CEF66}"/>
                    </a:ext>
                  </a:extLst>
                </p:cNvPr>
                <p:cNvGrpSpPr/>
                <p:nvPr/>
              </p:nvGrpSpPr>
              <p:grpSpPr>
                <a:xfrm>
                  <a:off x="5691272" y="4299548"/>
                  <a:ext cx="5317317" cy="2205549"/>
                  <a:chOff x="5691272" y="4004273"/>
                  <a:chExt cx="5317317" cy="2205549"/>
                </a:xfrm>
              </p:grpSpPr>
              <p:grpSp>
                <p:nvGrpSpPr>
                  <p:cNvPr id="5958" name="Gruppieren 5957">
                    <a:extLst>
                      <a:ext uri="{FF2B5EF4-FFF2-40B4-BE49-F238E27FC236}">
                        <a16:creationId xmlns:a16="http://schemas.microsoft.com/office/drawing/2014/main" id="{63E38231-C156-4E34-A142-810F46C88BBA}"/>
                      </a:ext>
                    </a:extLst>
                  </p:cNvPr>
                  <p:cNvGrpSpPr/>
                  <p:nvPr/>
                </p:nvGrpSpPr>
                <p:grpSpPr>
                  <a:xfrm>
                    <a:off x="5691272" y="4294415"/>
                    <a:ext cx="5317317" cy="1915407"/>
                    <a:chOff x="5691272" y="4294415"/>
                    <a:chExt cx="5317317" cy="1915407"/>
                  </a:xfrm>
                </p:grpSpPr>
                <p:pic>
                  <p:nvPicPr>
                    <p:cNvPr id="5902" name="Grafik 5901">
                      <a:extLst>
                        <a:ext uri="{FF2B5EF4-FFF2-40B4-BE49-F238E27FC236}">
                          <a16:creationId xmlns:a16="http://schemas.microsoft.com/office/drawing/2014/main" id="{DAB7508F-3D5B-495A-9643-E4B0EFABD28A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93164" t="35278" r="782" b="37168"/>
                    <a:stretch/>
                  </p:blipFill>
                  <p:spPr>
                    <a:xfrm>
                      <a:off x="10429424" y="4513590"/>
                      <a:ext cx="579165" cy="1171410"/>
                    </a:xfrm>
                    <a:prstGeom prst="rect">
                      <a:avLst/>
                    </a:prstGeom>
                  </p:spPr>
                </p:pic>
                <p:grpSp>
                  <p:nvGrpSpPr>
                    <p:cNvPr id="5903" name="Gruppieren 5902">
                      <a:extLst>
                        <a:ext uri="{FF2B5EF4-FFF2-40B4-BE49-F238E27FC236}">
                          <a16:creationId xmlns:a16="http://schemas.microsoft.com/office/drawing/2014/main" id="{33504696-639B-48FD-A788-F70C8E3427F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691272" y="4294415"/>
                      <a:ext cx="4964712" cy="1915407"/>
                      <a:chOff x="4289074" y="3935578"/>
                      <a:chExt cx="4964712" cy="1915407"/>
                    </a:xfrm>
                  </p:grpSpPr>
                  <p:pic>
                    <p:nvPicPr>
                      <p:cNvPr id="5894" name="Grafik 5893">
                        <a:extLst>
                          <a:ext uri="{FF2B5EF4-FFF2-40B4-BE49-F238E27FC236}">
                            <a16:creationId xmlns:a16="http://schemas.microsoft.com/office/drawing/2014/main" id="{0955C320-14D1-4EF0-887C-1EA13D3FE578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7942" t="3487" r="7342" b="5575"/>
                      <a:stretch/>
                    </p:blipFill>
                    <p:spPr>
                      <a:xfrm>
                        <a:off x="5401479" y="3935578"/>
                        <a:ext cx="3584637" cy="1609761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5895" name="Textfeld 5894">
                        <a:extLst>
                          <a:ext uri="{FF2B5EF4-FFF2-40B4-BE49-F238E27FC236}">
                            <a16:creationId xmlns:a16="http://schemas.microsoft.com/office/drawing/2014/main" id="{81542484-23DC-4420-A04F-044D0EC87DA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804453" y="5491749"/>
                        <a:ext cx="62634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b="1" dirty="0"/>
                          <a:t>0,125</a:t>
                        </a:r>
                      </a:p>
                    </p:txBody>
                  </p:sp>
                  <p:sp>
                    <p:nvSpPr>
                      <p:cNvPr id="5896" name="Textfeld 5895">
                        <a:extLst>
                          <a:ext uri="{FF2B5EF4-FFF2-40B4-BE49-F238E27FC236}">
                            <a16:creationId xmlns:a16="http://schemas.microsoft.com/office/drawing/2014/main" id="{EAEC3B3E-F9E3-4B19-AFA6-C4C5EB19D95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690546" y="5491749"/>
                        <a:ext cx="62634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b="1" dirty="0"/>
                          <a:t>0,150</a:t>
                        </a:r>
                      </a:p>
                    </p:txBody>
                  </p:sp>
                  <p:sp>
                    <p:nvSpPr>
                      <p:cNvPr id="5897" name="Textfeld 5896">
                        <a:extLst>
                          <a:ext uri="{FF2B5EF4-FFF2-40B4-BE49-F238E27FC236}">
                            <a16:creationId xmlns:a16="http://schemas.microsoft.com/office/drawing/2014/main" id="{F3EB3D6F-DE13-4CDB-88D6-5BF11D838EA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576639" y="5491749"/>
                        <a:ext cx="62634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b="1" dirty="0"/>
                          <a:t>0,175</a:t>
                        </a:r>
                      </a:p>
                    </p:txBody>
                  </p:sp>
                  <p:sp>
                    <p:nvSpPr>
                      <p:cNvPr id="5898" name="Textfeld 5897">
                        <a:extLst>
                          <a:ext uri="{FF2B5EF4-FFF2-40B4-BE49-F238E27FC236}">
                            <a16:creationId xmlns:a16="http://schemas.microsoft.com/office/drawing/2014/main" id="{AB562E52-48CB-48E5-B496-DA8C4015D11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462732" y="5491749"/>
                        <a:ext cx="62634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b="1" dirty="0"/>
                          <a:t>0,200</a:t>
                        </a:r>
                      </a:p>
                    </p:txBody>
                  </p:sp>
                  <p:sp>
                    <p:nvSpPr>
                      <p:cNvPr id="5899" name="Textfeld 5898">
                        <a:extLst>
                          <a:ext uri="{FF2B5EF4-FFF2-40B4-BE49-F238E27FC236}">
                            <a16:creationId xmlns:a16="http://schemas.microsoft.com/office/drawing/2014/main" id="{4273A47D-A4A4-40B2-99E9-B43E0AFE59F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400167" y="5620153"/>
                        <a:ext cx="3853619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900" dirty="0"/>
                          <a:t>Gene ratio</a:t>
                        </a:r>
                      </a:p>
                    </p:txBody>
                  </p:sp>
                  <p:sp>
                    <p:nvSpPr>
                      <p:cNvPr id="5900" name="Textfeld 5899">
                        <a:extLst>
                          <a:ext uri="{FF2B5EF4-FFF2-40B4-BE49-F238E27FC236}">
                            <a16:creationId xmlns:a16="http://schemas.microsoft.com/office/drawing/2014/main" id="{4D77D377-64EE-4473-9D65-AD6D5ACC9E8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289074" y="4636212"/>
                        <a:ext cx="1168243" cy="2000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700" b="1" dirty="0"/>
                          <a:t>Muscle contraction</a:t>
                        </a:r>
                      </a:p>
                    </p:txBody>
                  </p:sp>
                </p:grpSp>
              </p:grpSp>
              <p:sp>
                <p:nvSpPr>
                  <p:cNvPr id="3022" name="Textfeld 3021">
                    <a:extLst>
                      <a:ext uri="{FF2B5EF4-FFF2-40B4-BE49-F238E27FC236}">
                        <a16:creationId xmlns:a16="http://schemas.microsoft.com/office/drawing/2014/main" id="{0641BFC4-A7D6-448C-AA0D-678A64C5FF3B}"/>
                      </a:ext>
                    </a:extLst>
                  </p:cNvPr>
                  <p:cNvSpPr txBox="1"/>
                  <p:nvPr/>
                </p:nvSpPr>
                <p:spPr>
                  <a:xfrm>
                    <a:off x="7591526" y="4004273"/>
                    <a:ext cx="2171967" cy="261610"/>
                  </a:xfrm>
                  <a:prstGeom prst="rect">
                    <a:avLst/>
                  </a:prstGeom>
                  <a:noFill/>
                  <a:ln w="19050">
                    <a:solidFill>
                      <a:schemeClr val="accent1">
                        <a:lumMod val="60000"/>
                        <a:lumOff val="40000"/>
                      </a:schemeClr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dirty="0"/>
                      <a:t>Upregulated in primary CRC</a:t>
                    </a:r>
                  </a:p>
                </p:txBody>
              </p:sp>
            </p:grpSp>
          </p:grpSp>
        </p:grpSp>
        <p:grpSp>
          <p:nvGrpSpPr>
            <p:cNvPr id="5965" name="Gruppieren 5964">
              <a:extLst>
                <a:ext uri="{FF2B5EF4-FFF2-40B4-BE49-F238E27FC236}">
                  <a16:creationId xmlns:a16="http://schemas.microsoft.com/office/drawing/2014/main" id="{5E3969BD-7E19-4A5A-9185-78038975D2D0}"/>
                </a:ext>
              </a:extLst>
            </p:cNvPr>
            <p:cNvGrpSpPr/>
            <p:nvPr/>
          </p:nvGrpSpPr>
          <p:grpSpPr>
            <a:xfrm>
              <a:off x="191946" y="536461"/>
              <a:ext cx="5229821" cy="5867457"/>
              <a:chOff x="306246" y="536461"/>
              <a:chExt cx="5229821" cy="5867457"/>
            </a:xfrm>
          </p:grpSpPr>
          <p:sp>
            <p:nvSpPr>
              <p:cNvPr id="5927" name="Textfeld 5926">
                <a:extLst>
                  <a:ext uri="{FF2B5EF4-FFF2-40B4-BE49-F238E27FC236}">
                    <a16:creationId xmlns:a16="http://schemas.microsoft.com/office/drawing/2014/main" id="{99BAF24C-BEF8-4FD7-ADAD-C7D8A997DE86}"/>
                  </a:ext>
                </a:extLst>
              </p:cNvPr>
              <p:cNvSpPr txBox="1"/>
              <p:nvPr/>
            </p:nvSpPr>
            <p:spPr>
              <a:xfrm>
                <a:off x="382734" y="536461"/>
                <a:ext cx="49560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 err="1"/>
                  <a:t>Reactome</a:t>
                </a:r>
                <a:r>
                  <a:rPr lang="en-US" sz="1600" b="1" dirty="0"/>
                  <a:t> analysis dissected proteome data</a:t>
                </a:r>
              </a:p>
            </p:txBody>
          </p:sp>
          <p:grpSp>
            <p:nvGrpSpPr>
              <p:cNvPr id="5962" name="Gruppieren 5961">
                <a:extLst>
                  <a:ext uri="{FF2B5EF4-FFF2-40B4-BE49-F238E27FC236}">
                    <a16:creationId xmlns:a16="http://schemas.microsoft.com/office/drawing/2014/main" id="{B4EA2E3B-A5B9-454C-960B-30820974711F}"/>
                  </a:ext>
                </a:extLst>
              </p:cNvPr>
              <p:cNvGrpSpPr/>
              <p:nvPr/>
            </p:nvGrpSpPr>
            <p:grpSpPr>
              <a:xfrm>
                <a:off x="306246" y="906134"/>
                <a:ext cx="5229821" cy="5497784"/>
                <a:chOff x="306246" y="906134"/>
                <a:chExt cx="5229821" cy="5497784"/>
              </a:xfrm>
            </p:grpSpPr>
            <p:grpSp>
              <p:nvGrpSpPr>
                <p:cNvPr id="5956" name="Gruppieren 5955">
                  <a:extLst>
                    <a:ext uri="{FF2B5EF4-FFF2-40B4-BE49-F238E27FC236}">
                      <a16:creationId xmlns:a16="http://schemas.microsoft.com/office/drawing/2014/main" id="{CEB22A49-497E-49E4-99F7-133C39235FAA}"/>
                    </a:ext>
                  </a:extLst>
                </p:cNvPr>
                <p:cNvGrpSpPr/>
                <p:nvPr/>
              </p:nvGrpSpPr>
              <p:grpSpPr>
                <a:xfrm>
                  <a:off x="306246" y="906134"/>
                  <a:ext cx="5032584" cy="3345910"/>
                  <a:chOff x="306246" y="610859"/>
                  <a:chExt cx="5032584" cy="3345910"/>
                </a:xfrm>
              </p:grpSpPr>
              <p:grpSp>
                <p:nvGrpSpPr>
                  <p:cNvPr id="5951" name="Gruppieren 5950">
                    <a:extLst>
                      <a:ext uri="{FF2B5EF4-FFF2-40B4-BE49-F238E27FC236}">
                        <a16:creationId xmlns:a16="http://schemas.microsoft.com/office/drawing/2014/main" id="{5D00BA99-8C80-405A-A820-4DE212E8C385}"/>
                      </a:ext>
                    </a:extLst>
                  </p:cNvPr>
                  <p:cNvGrpSpPr/>
                  <p:nvPr/>
                </p:nvGrpSpPr>
                <p:grpSpPr>
                  <a:xfrm>
                    <a:off x="306246" y="883800"/>
                    <a:ext cx="5032584" cy="3072969"/>
                    <a:chOff x="306246" y="893929"/>
                    <a:chExt cx="5032584" cy="3072969"/>
                  </a:xfrm>
                </p:grpSpPr>
                <p:sp>
                  <p:nvSpPr>
                    <p:cNvPr id="5908" name="Textfeld 5907">
                      <a:extLst>
                        <a:ext uri="{FF2B5EF4-FFF2-40B4-BE49-F238E27FC236}">
                          <a16:creationId xmlns:a16="http://schemas.microsoft.com/office/drawing/2014/main" id="{0F9E955D-E65C-4CC7-A3E3-4F8BF1F37DB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6246" y="917248"/>
                      <a:ext cx="1528307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700" b="1" dirty="0"/>
                        <a:t>Platelet activation, signaling and aggregation</a:t>
                      </a:r>
                    </a:p>
                  </p:txBody>
                </p:sp>
                <p:sp>
                  <p:nvSpPr>
                    <p:cNvPr id="5909" name="Textfeld 5908">
                      <a:extLst>
                        <a:ext uri="{FF2B5EF4-FFF2-40B4-BE49-F238E27FC236}">
                          <a16:creationId xmlns:a16="http://schemas.microsoft.com/office/drawing/2014/main" id="{C5D868E0-6156-4F2B-B9A0-A5491569008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6246" y="1171052"/>
                      <a:ext cx="1528307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700" b="1" dirty="0"/>
                        <a:t>Regulation of IGF transport and uptake by IGFBPs</a:t>
                      </a:r>
                    </a:p>
                  </p:txBody>
                </p:sp>
                <p:sp>
                  <p:nvSpPr>
                    <p:cNvPr id="5910" name="Textfeld 5909">
                      <a:extLst>
                        <a:ext uri="{FF2B5EF4-FFF2-40B4-BE49-F238E27FC236}">
                          <a16:creationId xmlns:a16="http://schemas.microsoft.com/office/drawing/2014/main" id="{D8EDAC74-7F29-49B8-BA8E-455CE2BCCCA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6246" y="1486775"/>
                      <a:ext cx="1528307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700" b="1" dirty="0"/>
                        <a:t>Platelet degranulation</a:t>
                      </a:r>
                    </a:p>
                  </p:txBody>
                </p:sp>
                <p:sp>
                  <p:nvSpPr>
                    <p:cNvPr id="5911" name="Textfeld 5910">
                      <a:extLst>
                        <a:ext uri="{FF2B5EF4-FFF2-40B4-BE49-F238E27FC236}">
                          <a16:creationId xmlns:a16="http://schemas.microsoft.com/office/drawing/2014/main" id="{7F507E42-6DBC-42D3-B45D-93F079FD5D9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6246" y="1691113"/>
                      <a:ext cx="1528307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700" b="1" dirty="0"/>
                        <a:t>Response to elevated platelet cytosolic Ca2+</a:t>
                      </a:r>
                    </a:p>
                  </p:txBody>
                </p:sp>
                <p:sp>
                  <p:nvSpPr>
                    <p:cNvPr id="5912" name="Textfeld 5911">
                      <a:extLst>
                        <a:ext uri="{FF2B5EF4-FFF2-40B4-BE49-F238E27FC236}">
                          <a16:creationId xmlns:a16="http://schemas.microsoft.com/office/drawing/2014/main" id="{E6CABACC-A485-440E-96F7-04DDAAEEA2B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6246" y="1992547"/>
                      <a:ext cx="1528307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700" b="1" dirty="0"/>
                        <a:t>Metabolism of vitamins and cofactors</a:t>
                      </a:r>
                    </a:p>
                  </p:txBody>
                </p:sp>
                <p:sp>
                  <p:nvSpPr>
                    <p:cNvPr id="5913" name="Textfeld 5912">
                      <a:extLst>
                        <a:ext uri="{FF2B5EF4-FFF2-40B4-BE49-F238E27FC236}">
                          <a16:creationId xmlns:a16="http://schemas.microsoft.com/office/drawing/2014/main" id="{7BECD1ED-489A-4EBC-BD61-C196E9BB16F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6246" y="2246351"/>
                      <a:ext cx="1528307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700" b="1" dirty="0"/>
                        <a:t>Metabolism of water-soluble vitamins and cofactors</a:t>
                      </a:r>
                    </a:p>
                  </p:txBody>
                </p:sp>
                <p:sp>
                  <p:nvSpPr>
                    <p:cNvPr id="5914" name="Textfeld 5913">
                      <a:extLst>
                        <a:ext uri="{FF2B5EF4-FFF2-40B4-BE49-F238E27FC236}">
                          <a16:creationId xmlns:a16="http://schemas.microsoft.com/office/drawing/2014/main" id="{39676485-FD4F-4967-9622-E19FCD34654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4175" y="2552548"/>
                      <a:ext cx="1450378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700" b="1" dirty="0"/>
                        <a:t>Terminal pathway of complement</a:t>
                      </a:r>
                    </a:p>
                  </p:txBody>
                </p:sp>
                <p:sp>
                  <p:nvSpPr>
                    <p:cNvPr id="5915" name="Textfeld 5914">
                      <a:extLst>
                        <a:ext uri="{FF2B5EF4-FFF2-40B4-BE49-F238E27FC236}">
                          <a16:creationId xmlns:a16="http://schemas.microsoft.com/office/drawing/2014/main" id="{426B9FB9-03D8-4DCD-9ABB-21A074BD0EA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6246" y="2823567"/>
                      <a:ext cx="1528307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700" b="1" dirty="0"/>
                        <a:t>Creation of C4 and C2 activators</a:t>
                      </a:r>
                    </a:p>
                  </p:txBody>
                </p:sp>
                <p:sp>
                  <p:nvSpPr>
                    <p:cNvPr id="5916" name="Textfeld 5915">
                      <a:extLst>
                        <a:ext uri="{FF2B5EF4-FFF2-40B4-BE49-F238E27FC236}">
                          <a16:creationId xmlns:a16="http://schemas.microsoft.com/office/drawing/2014/main" id="{3D1F328E-7801-4D61-8243-FBD6DF0C2CC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6246" y="3034505"/>
                      <a:ext cx="1528307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700" b="1" dirty="0"/>
                        <a:t>Classical antibody-mediated complement activation</a:t>
                      </a:r>
                    </a:p>
                  </p:txBody>
                </p:sp>
                <p:sp>
                  <p:nvSpPr>
                    <p:cNvPr id="5917" name="Textfeld 5916">
                      <a:extLst>
                        <a:ext uri="{FF2B5EF4-FFF2-40B4-BE49-F238E27FC236}">
                          <a16:creationId xmlns:a16="http://schemas.microsoft.com/office/drawing/2014/main" id="{551E08FC-2178-4216-9EFB-A7FAEC1B768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6246" y="3354990"/>
                      <a:ext cx="1528307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700" b="1" dirty="0"/>
                        <a:t>Fructose catabolism</a:t>
                      </a:r>
                    </a:p>
                  </p:txBody>
                </p:sp>
                <p:grpSp>
                  <p:nvGrpSpPr>
                    <p:cNvPr id="5947" name="Gruppieren 5946">
                      <a:extLst>
                        <a:ext uri="{FF2B5EF4-FFF2-40B4-BE49-F238E27FC236}">
                          <a16:creationId xmlns:a16="http://schemas.microsoft.com/office/drawing/2014/main" id="{6C4DFC16-EDFB-4801-9DCB-8D450F3AB61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623938" y="893929"/>
                      <a:ext cx="3714892" cy="3072969"/>
                      <a:chOff x="1623938" y="893929"/>
                      <a:chExt cx="3714892" cy="3072969"/>
                    </a:xfrm>
                  </p:grpSpPr>
                  <p:pic>
                    <p:nvPicPr>
                      <p:cNvPr id="5907" name="Grafik 5906">
                        <a:extLst>
                          <a:ext uri="{FF2B5EF4-FFF2-40B4-BE49-F238E27FC236}">
                            <a16:creationId xmlns:a16="http://schemas.microsoft.com/office/drawing/2014/main" id="{69B38C98-A490-4758-B099-637BFA2690E8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9264" t="3708" r="5333" b="5472"/>
                      <a:stretch/>
                    </p:blipFill>
                    <p:spPr>
                      <a:xfrm>
                        <a:off x="1766938" y="893929"/>
                        <a:ext cx="3096866" cy="2753183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5918" name="Textfeld 5917">
                        <a:extLst>
                          <a:ext uri="{FF2B5EF4-FFF2-40B4-BE49-F238E27FC236}">
                            <a16:creationId xmlns:a16="http://schemas.microsoft.com/office/drawing/2014/main" id="{E9C7F62E-A59B-4D46-B37F-B5BAC729155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623938" y="3579285"/>
                        <a:ext cx="62634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b="1" dirty="0"/>
                          <a:t>0,04</a:t>
                        </a:r>
                      </a:p>
                    </p:txBody>
                  </p:sp>
                  <p:sp>
                    <p:nvSpPr>
                      <p:cNvPr id="5919" name="Textfeld 5918">
                        <a:extLst>
                          <a:ext uri="{FF2B5EF4-FFF2-40B4-BE49-F238E27FC236}">
                            <a16:creationId xmlns:a16="http://schemas.microsoft.com/office/drawing/2014/main" id="{F99ADA4B-333E-4692-B5BA-BB7A32E394E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544365" y="3579285"/>
                        <a:ext cx="62634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b="1" dirty="0"/>
                          <a:t>0,08</a:t>
                        </a:r>
                      </a:p>
                    </p:txBody>
                  </p:sp>
                  <p:sp>
                    <p:nvSpPr>
                      <p:cNvPr id="5920" name="Textfeld 5919">
                        <a:extLst>
                          <a:ext uri="{FF2B5EF4-FFF2-40B4-BE49-F238E27FC236}">
                            <a16:creationId xmlns:a16="http://schemas.microsoft.com/office/drawing/2014/main" id="{5FFAA866-04FD-4E52-983B-83934A2BB92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464792" y="3579285"/>
                        <a:ext cx="62634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b="1" dirty="0"/>
                          <a:t>0,12</a:t>
                        </a:r>
                      </a:p>
                    </p:txBody>
                  </p:sp>
                  <p:sp>
                    <p:nvSpPr>
                      <p:cNvPr id="5921" name="Textfeld 5920">
                        <a:extLst>
                          <a:ext uri="{FF2B5EF4-FFF2-40B4-BE49-F238E27FC236}">
                            <a16:creationId xmlns:a16="http://schemas.microsoft.com/office/drawing/2014/main" id="{1895D4A8-8FF3-426A-86EF-9F37C371DD8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85219" y="3579285"/>
                        <a:ext cx="62634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b="1" dirty="0"/>
                          <a:t>0,16</a:t>
                        </a:r>
                      </a:p>
                    </p:txBody>
                  </p:sp>
                  <p:sp>
                    <p:nvSpPr>
                      <p:cNvPr id="5922" name="Textfeld 5921">
                        <a:extLst>
                          <a:ext uri="{FF2B5EF4-FFF2-40B4-BE49-F238E27FC236}">
                            <a16:creationId xmlns:a16="http://schemas.microsoft.com/office/drawing/2014/main" id="{0F2C2544-F1EF-4880-8D0E-65EEE56F3F8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766938" y="3736066"/>
                        <a:ext cx="3096866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900" dirty="0"/>
                          <a:t>Gene ratio</a:t>
                        </a:r>
                      </a:p>
                    </p:txBody>
                  </p:sp>
                  <p:pic>
                    <p:nvPicPr>
                      <p:cNvPr id="5925" name="Grafik 5924">
                        <a:extLst>
                          <a:ext uri="{FF2B5EF4-FFF2-40B4-BE49-F238E27FC236}">
                            <a16:creationId xmlns:a16="http://schemas.microsoft.com/office/drawing/2014/main" id="{A73EFEEB-DBB2-4C02-880C-5549E5230D43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95651" t="24921" r="697" b="26505"/>
                      <a:stretch/>
                    </p:blipFill>
                    <p:spPr>
                      <a:xfrm>
                        <a:off x="4942118" y="1098074"/>
                        <a:ext cx="396712" cy="2344893"/>
                      </a:xfrm>
                      <a:prstGeom prst="rect">
                        <a:avLst/>
                      </a:prstGeom>
                    </p:spPr>
                  </p:pic>
                </p:grpSp>
              </p:grpSp>
              <p:sp>
                <p:nvSpPr>
                  <p:cNvPr id="5928" name="Textfeld 5927">
                    <a:extLst>
                      <a:ext uri="{FF2B5EF4-FFF2-40B4-BE49-F238E27FC236}">
                        <a16:creationId xmlns:a16="http://schemas.microsoft.com/office/drawing/2014/main" id="{BF74DC47-6024-47BB-AD17-CEAE57F99891}"/>
                      </a:ext>
                    </a:extLst>
                  </p:cNvPr>
                  <p:cNvSpPr txBox="1"/>
                  <p:nvPr/>
                </p:nvSpPr>
                <p:spPr>
                  <a:xfrm>
                    <a:off x="1908148" y="610859"/>
                    <a:ext cx="2399201" cy="261610"/>
                  </a:xfrm>
                  <a:prstGeom prst="rect">
                    <a:avLst/>
                  </a:prstGeom>
                  <a:noFill/>
                  <a:ln w="19050">
                    <a:solidFill>
                      <a:schemeClr val="accent4">
                        <a:lumMod val="60000"/>
                        <a:lumOff val="40000"/>
                      </a:schemeClr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dirty="0"/>
                      <a:t>Upregulated in liver metastasis</a:t>
                    </a:r>
                  </a:p>
                </p:txBody>
              </p:sp>
            </p:grpSp>
            <p:grpSp>
              <p:nvGrpSpPr>
                <p:cNvPr id="5961" name="Gruppieren 5960">
                  <a:extLst>
                    <a:ext uri="{FF2B5EF4-FFF2-40B4-BE49-F238E27FC236}">
                      <a16:creationId xmlns:a16="http://schemas.microsoft.com/office/drawing/2014/main" id="{0180F8CD-8E9F-4E46-90AB-1C1745B9426B}"/>
                    </a:ext>
                  </a:extLst>
                </p:cNvPr>
                <p:cNvGrpSpPr/>
                <p:nvPr/>
              </p:nvGrpSpPr>
              <p:grpSpPr>
                <a:xfrm>
                  <a:off x="669820" y="4318598"/>
                  <a:ext cx="4866247" cy="2085320"/>
                  <a:chOff x="669820" y="4023323"/>
                  <a:chExt cx="4866247" cy="2085320"/>
                </a:xfrm>
              </p:grpSpPr>
              <p:sp>
                <p:nvSpPr>
                  <p:cNvPr id="5938" name="Textfeld 5937">
                    <a:extLst>
                      <a:ext uri="{FF2B5EF4-FFF2-40B4-BE49-F238E27FC236}">
                        <a16:creationId xmlns:a16="http://schemas.microsoft.com/office/drawing/2014/main" id="{A626F74C-D793-4ACE-BFF2-3FC6DC25CEDA}"/>
                      </a:ext>
                    </a:extLst>
                  </p:cNvPr>
                  <p:cNvSpPr txBox="1"/>
                  <p:nvPr/>
                </p:nvSpPr>
                <p:spPr>
                  <a:xfrm>
                    <a:off x="2016960" y="4023323"/>
                    <a:ext cx="2171967" cy="261610"/>
                  </a:xfrm>
                  <a:prstGeom prst="rect">
                    <a:avLst/>
                  </a:prstGeom>
                  <a:noFill/>
                  <a:ln w="19050">
                    <a:solidFill>
                      <a:schemeClr val="accent1">
                        <a:lumMod val="60000"/>
                        <a:lumOff val="40000"/>
                      </a:schemeClr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dirty="0"/>
                      <a:t>Upregulated in primary CRC</a:t>
                    </a:r>
                  </a:p>
                </p:txBody>
              </p:sp>
              <p:grpSp>
                <p:nvGrpSpPr>
                  <p:cNvPr id="5960" name="Gruppieren 5959">
                    <a:extLst>
                      <a:ext uri="{FF2B5EF4-FFF2-40B4-BE49-F238E27FC236}">
                        <a16:creationId xmlns:a16="http://schemas.microsoft.com/office/drawing/2014/main" id="{6BAC2691-AB27-41AD-B69A-20C8F0679A95}"/>
                      </a:ext>
                    </a:extLst>
                  </p:cNvPr>
                  <p:cNvGrpSpPr/>
                  <p:nvPr/>
                </p:nvGrpSpPr>
                <p:grpSpPr>
                  <a:xfrm>
                    <a:off x="669820" y="4314334"/>
                    <a:ext cx="4866247" cy="1794309"/>
                    <a:chOff x="669820" y="4314334"/>
                    <a:chExt cx="4866247" cy="1794309"/>
                  </a:xfrm>
                </p:grpSpPr>
                <p:sp>
                  <p:nvSpPr>
                    <p:cNvPr id="5932" name="Textfeld 5931">
                      <a:extLst>
                        <a:ext uri="{FF2B5EF4-FFF2-40B4-BE49-F238E27FC236}">
                          <a16:creationId xmlns:a16="http://schemas.microsoft.com/office/drawing/2014/main" id="{AB96FF5D-1033-4797-9DE3-D7BEFC4F4EE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56254" y="5727426"/>
                      <a:ext cx="626347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/>
                        <a:t>0,175</a:t>
                      </a:r>
                    </a:p>
                  </p:txBody>
                </p:sp>
                <p:sp>
                  <p:nvSpPr>
                    <p:cNvPr id="5933" name="Textfeld 5932">
                      <a:extLst>
                        <a:ext uri="{FF2B5EF4-FFF2-40B4-BE49-F238E27FC236}">
                          <a16:creationId xmlns:a16="http://schemas.microsoft.com/office/drawing/2014/main" id="{C7868DAA-F19C-46AA-9945-FA2003D9140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13830" y="5727426"/>
                      <a:ext cx="626347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/>
                        <a:t>0,200</a:t>
                      </a:r>
                    </a:p>
                  </p:txBody>
                </p:sp>
                <p:sp>
                  <p:nvSpPr>
                    <p:cNvPr id="5934" name="Textfeld 5933">
                      <a:extLst>
                        <a:ext uri="{FF2B5EF4-FFF2-40B4-BE49-F238E27FC236}">
                          <a16:creationId xmlns:a16="http://schemas.microsoft.com/office/drawing/2014/main" id="{06F18FC3-0688-41D5-B336-F32A0DFD8D2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71406" y="5727426"/>
                      <a:ext cx="626347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/>
                        <a:t>0,225</a:t>
                      </a:r>
                    </a:p>
                  </p:txBody>
                </p:sp>
                <p:sp>
                  <p:nvSpPr>
                    <p:cNvPr id="5935" name="Textfeld 5934">
                      <a:extLst>
                        <a:ext uri="{FF2B5EF4-FFF2-40B4-BE49-F238E27FC236}">
                          <a16:creationId xmlns:a16="http://schemas.microsoft.com/office/drawing/2014/main" id="{0F17090F-3176-4E7A-BBE1-F4303ABAAAF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928983" y="5727426"/>
                      <a:ext cx="626347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/>
                        <a:t>0,250</a:t>
                      </a:r>
                    </a:p>
                  </p:txBody>
                </p:sp>
                <p:sp>
                  <p:nvSpPr>
                    <p:cNvPr id="5936" name="Textfeld 5935">
                      <a:extLst>
                        <a:ext uri="{FF2B5EF4-FFF2-40B4-BE49-F238E27FC236}">
                          <a16:creationId xmlns:a16="http://schemas.microsoft.com/office/drawing/2014/main" id="{A01A8FEF-A0AA-4273-AF83-ADB77B2327A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01290" y="5877811"/>
                      <a:ext cx="3062514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dirty="0"/>
                        <a:t>Gene ratio</a:t>
                      </a:r>
                    </a:p>
                  </p:txBody>
                </p:sp>
                <p:sp>
                  <p:nvSpPr>
                    <p:cNvPr id="5937" name="Textfeld 5936">
                      <a:extLst>
                        <a:ext uri="{FF2B5EF4-FFF2-40B4-BE49-F238E27FC236}">
                          <a16:creationId xmlns:a16="http://schemas.microsoft.com/office/drawing/2014/main" id="{B415C8AC-DB03-4702-A8C2-AE6B37739FA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69820" y="4935637"/>
                      <a:ext cx="1168243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700" b="1" dirty="0"/>
                        <a:t>Muscle contraction</a:t>
                      </a:r>
                    </a:p>
                  </p:txBody>
                </p:sp>
                <p:pic>
                  <p:nvPicPr>
                    <p:cNvPr id="5940" name="Grafik 5939">
                      <a:extLst>
                        <a:ext uri="{FF2B5EF4-FFF2-40B4-BE49-F238E27FC236}">
                          <a16:creationId xmlns:a16="http://schemas.microsoft.com/office/drawing/2014/main" id="{220F5F88-418E-426B-A9F1-7D2D043EC37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5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8073" t="3647" r="7250" b="5708"/>
                    <a:stretch/>
                  </p:blipFill>
                  <p:spPr>
                    <a:xfrm>
                      <a:off x="1801290" y="4314334"/>
                      <a:ext cx="3062514" cy="1457050"/>
                    </a:xfrm>
                    <a:prstGeom prst="rect">
                      <a:avLst/>
                    </a:prstGeom>
                  </p:spPr>
                </p:pic>
                <p:grpSp>
                  <p:nvGrpSpPr>
                    <p:cNvPr id="5945" name="Gruppieren 5944">
                      <a:extLst>
                        <a:ext uri="{FF2B5EF4-FFF2-40B4-BE49-F238E27FC236}">
                          <a16:creationId xmlns:a16="http://schemas.microsoft.com/office/drawing/2014/main" id="{FE1848F9-6D2B-492D-A565-8EBC89D3F89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923264" y="4438300"/>
                      <a:ext cx="612803" cy="1209119"/>
                      <a:chOff x="5110596" y="4171533"/>
                      <a:chExt cx="708029" cy="1397009"/>
                    </a:xfrm>
                  </p:grpSpPr>
                  <p:pic>
                    <p:nvPicPr>
                      <p:cNvPr id="5942" name="Grafik 5941">
                        <a:extLst>
                          <a:ext uri="{FF2B5EF4-FFF2-40B4-BE49-F238E27FC236}">
                            <a16:creationId xmlns:a16="http://schemas.microsoft.com/office/drawing/2014/main" id="{3A56B186-5BF2-4A57-BD31-43BB4463F2EF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93496" t="35192" r="697" b="46835"/>
                      <a:stretch/>
                    </p:blipFill>
                    <p:spPr>
                      <a:xfrm>
                        <a:off x="5110596" y="4594611"/>
                        <a:ext cx="708029" cy="973931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5944" name="Grafik 5943">
                        <a:extLst>
                          <a:ext uri="{FF2B5EF4-FFF2-40B4-BE49-F238E27FC236}">
                            <a16:creationId xmlns:a16="http://schemas.microsoft.com/office/drawing/2014/main" id="{79ED3610-A679-4F26-910F-6CCFED3122F8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93620" t="56546" r="3619" b="36888"/>
                      <a:stretch/>
                    </p:blipFill>
                    <p:spPr>
                      <a:xfrm>
                        <a:off x="5110596" y="4171533"/>
                        <a:ext cx="336550" cy="355774"/>
                      </a:xfrm>
                      <a:prstGeom prst="rect">
                        <a:avLst/>
                      </a:prstGeom>
                    </p:spPr>
                  </p:pic>
                </p:grpSp>
              </p:grpSp>
            </p:grpSp>
          </p:grpSp>
        </p:grpSp>
      </p:grpSp>
    </p:spTree>
    <p:extLst>
      <p:ext uri="{BB962C8B-B14F-4D97-AF65-F5344CB8AC3E}">
        <p14:creationId xmlns:p14="http://schemas.microsoft.com/office/powerpoint/2010/main" val="19278750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8</Words>
  <Application>Microsoft Office PowerPoint</Application>
  <PresentationFormat>Breitbild</PresentationFormat>
  <Paragraphs>5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tthias Fahrner</dc:creator>
  <cp:lastModifiedBy>Matthias Fahrner</cp:lastModifiedBy>
  <cp:revision>14</cp:revision>
  <dcterms:created xsi:type="dcterms:W3CDTF">2021-07-28T17:16:09Z</dcterms:created>
  <dcterms:modified xsi:type="dcterms:W3CDTF">2021-08-11T15:04:32Z</dcterms:modified>
</cp:coreProperties>
</file>